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.M. Wilting" initials="SW" lastIdx="9" clrIdx="0">
    <p:extLst>
      <p:ext uri="{19B8F6BF-5375-455C-9EA6-DF929625EA0E}">
        <p15:presenceInfo xmlns:p15="http://schemas.microsoft.com/office/powerpoint/2012/main" userId="S-1-5-21-932686498-1610486119-1155464205-202869" providerId="AD"/>
      </p:ext>
    </p:extLst>
  </p:cmAuthor>
  <p:cmAuthor id="2" name="T. Deger" initials="TD" lastIdx="2" clrIdx="1">
    <p:extLst>
      <p:ext uri="{19B8F6BF-5375-455C-9EA6-DF929625EA0E}">
        <p15:presenceInfo xmlns:p15="http://schemas.microsoft.com/office/powerpoint/2012/main" userId="S-1-5-21-932686498-1610486119-1155464205-24066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B21C5"/>
    <a:srgbClr val="4565EB"/>
    <a:srgbClr val="AD4FE1"/>
    <a:srgbClr val="5B9BD5"/>
    <a:srgbClr val="A020F0"/>
    <a:srgbClr val="96919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699" autoAdjust="0"/>
    <p:restoredTop sz="97459" autoAdjust="0"/>
  </p:normalViewPr>
  <p:slideViewPr>
    <p:cSldViewPr snapToGrid="0">
      <p:cViewPr varScale="1">
        <p:scale>
          <a:sx n="60" d="100"/>
          <a:sy n="60" d="100"/>
        </p:scale>
        <p:origin x="192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0E9C5-A077-49EB-BDE6-1DA9E901EF56}" type="datetimeFigureOut">
              <a:rPr lang="en-GB" smtClean="0"/>
              <a:t>09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0D5A4-4C1A-40C2-B5BC-23EDC14876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58510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0E9C5-A077-49EB-BDE6-1DA9E901EF56}" type="datetimeFigureOut">
              <a:rPr lang="en-GB" smtClean="0"/>
              <a:t>09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0D5A4-4C1A-40C2-B5BC-23EDC14876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84354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0E9C5-A077-49EB-BDE6-1DA9E901EF56}" type="datetimeFigureOut">
              <a:rPr lang="en-GB" smtClean="0"/>
              <a:t>09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0D5A4-4C1A-40C2-B5BC-23EDC14876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67372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0E9C5-A077-49EB-BDE6-1DA9E901EF56}" type="datetimeFigureOut">
              <a:rPr lang="en-GB" smtClean="0"/>
              <a:t>09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0D5A4-4C1A-40C2-B5BC-23EDC14876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09304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0E9C5-A077-49EB-BDE6-1DA9E901EF56}" type="datetimeFigureOut">
              <a:rPr lang="en-GB" smtClean="0"/>
              <a:t>09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0D5A4-4C1A-40C2-B5BC-23EDC14876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94058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0E9C5-A077-49EB-BDE6-1DA9E901EF56}" type="datetimeFigureOut">
              <a:rPr lang="en-GB" smtClean="0"/>
              <a:t>09/1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0D5A4-4C1A-40C2-B5BC-23EDC14876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36917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0E9C5-A077-49EB-BDE6-1DA9E901EF56}" type="datetimeFigureOut">
              <a:rPr lang="en-GB" smtClean="0"/>
              <a:t>09/10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0D5A4-4C1A-40C2-B5BC-23EDC14876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96785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0E9C5-A077-49EB-BDE6-1DA9E901EF56}" type="datetimeFigureOut">
              <a:rPr lang="en-GB" smtClean="0"/>
              <a:t>09/10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0D5A4-4C1A-40C2-B5BC-23EDC14876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90540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0E9C5-A077-49EB-BDE6-1DA9E901EF56}" type="datetimeFigureOut">
              <a:rPr lang="en-GB" smtClean="0"/>
              <a:t>09/10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0D5A4-4C1A-40C2-B5BC-23EDC14876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66647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0E9C5-A077-49EB-BDE6-1DA9E901EF56}" type="datetimeFigureOut">
              <a:rPr lang="en-GB" smtClean="0"/>
              <a:t>09/1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0D5A4-4C1A-40C2-B5BC-23EDC14876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24234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0E9C5-A077-49EB-BDE6-1DA9E901EF56}" type="datetimeFigureOut">
              <a:rPr lang="en-GB" smtClean="0"/>
              <a:t>09/1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0D5A4-4C1A-40C2-B5BC-23EDC14876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84020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50E9C5-A077-49EB-BDE6-1DA9E901EF56}" type="datetimeFigureOut">
              <a:rPr lang="en-GB" smtClean="0"/>
              <a:t>09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A0D5A4-4C1A-40C2-B5BC-23EDC14876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59530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16643"/>
            <a:ext cx="685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Supplementary Figure </a:t>
            </a:r>
            <a:r>
              <a:rPr lang="en-US" sz="1100" dirty="0" smtClean="0"/>
              <a:t>2 – Observed correlations between biological replicates compared to HBDs </a:t>
            </a:r>
            <a:endParaRPr lang="en-GB" sz="1100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53246"/>
            <a:ext cx="6858000" cy="4037436"/>
          </a:xfrm>
          <a:prstGeom prst="rect">
            <a:avLst/>
          </a:prstGeom>
        </p:spPr>
      </p:pic>
      <p:sp>
        <p:nvSpPr>
          <p:cNvPr id="11" name="Left Bracket 10"/>
          <p:cNvSpPr/>
          <p:nvPr/>
        </p:nvSpPr>
        <p:spPr>
          <a:xfrm rot="5400000">
            <a:off x="4309104" y="436410"/>
            <a:ext cx="143909" cy="553333"/>
          </a:xfrm>
          <a:prstGeom prst="leftBracket">
            <a:avLst>
              <a:gd name="adj" fmla="val 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n>
                <a:solidFill>
                  <a:sysClr val="windowText" lastClr="000000"/>
                </a:solidFill>
              </a:ln>
              <a:solidFill>
                <a:sysClr val="windowText" lastClr="000000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263077" y="44552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/>
              <a:t>*</a:t>
            </a:r>
            <a:endParaRPr lang="en-GB" sz="800" dirty="0"/>
          </a:p>
        </p:txBody>
      </p:sp>
      <p:sp>
        <p:nvSpPr>
          <p:cNvPr id="13" name="Left Bracket 12"/>
          <p:cNvSpPr/>
          <p:nvPr/>
        </p:nvSpPr>
        <p:spPr>
          <a:xfrm rot="5400000">
            <a:off x="2937504" y="434041"/>
            <a:ext cx="143909" cy="553333"/>
          </a:xfrm>
          <a:prstGeom prst="leftBracket">
            <a:avLst>
              <a:gd name="adj" fmla="val 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n>
                <a:solidFill>
                  <a:sysClr val="windowText" lastClr="000000"/>
                </a:solidFill>
              </a:ln>
              <a:solidFill>
                <a:sysClr val="windowText" lastClr="000000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840181" y="44552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/>
              <a:t>***</a:t>
            </a:r>
            <a:endParaRPr lang="en-GB" sz="800" dirty="0"/>
          </a:p>
        </p:txBody>
      </p:sp>
      <p:sp>
        <p:nvSpPr>
          <p:cNvPr id="15" name="Left Bracket 14"/>
          <p:cNvSpPr/>
          <p:nvPr/>
        </p:nvSpPr>
        <p:spPr>
          <a:xfrm rot="5400000">
            <a:off x="1565334" y="434041"/>
            <a:ext cx="143909" cy="553333"/>
          </a:xfrm>
          <a:prstGeom prst="leftBracket">
            <a:avLst>
              <a:gd name="adj" fmla="val 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n>
                <a:solidFill>
                  <a:sysClr val="windowText" lastClr="000000"/>
                </a:solidFill>
              </a:ln>
              <a:solidFill>
                <a:sysClr val="windowText" lastClr="000000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493945" y="445524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/>
              <a:t>**</a:t>
            </a:r>
            <a:endParaRPr lang="en-GB" sz="800" dirty="0"/>
          </a:p>
        </p:txBody>
      </p:sp>
    </p:spTree>
    <p:extLst>
      <p:ext uri="{BB962C8B-B14F-4D97-AF65-F5344CB8AC3E}">
        <p14:creationId xmlns:p14="http://schemas.microsoft.com/office/powerpoint/2010/main" val="19004633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923</TotalTime>
  <Words>15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Erasmus M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.M. Wilting</dc:creator>
  <cp:lastModifiedBy>Sivagnanam K.</cp:lastModifiedBy>
  <cp:revision>220</cp:revision>
  <dcterms:created xsi:type="dcterms:W3CDTF">2020-04-30T13:40:18Z</dcterms:created>
  <dcterms:modified xsi:type="dcterms:W3CDTF">2021-10-09T04:18:11Z</dcterms:modified>
</cp:coreProperties>
</file>